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644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DF9DD56-3D08-9408-2008-264575CC0D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0888825-D112-FDF5-64F5-236133C278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0A660D-6A52-24A1-48E7-178C3E6B3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936E01F-AAA7-6069-8675-F262F059D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C51FF7D-5B99-5C1C-40E5-0BF5DA12F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92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D011EF-2529-4692-BEFE-5C71A8DA4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E77D07F-7A04-E25C-053B-8F4BD8588A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C83EC3-DDB6-0D54-2A87-1FE5977AE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DC095A-98C0-6D9E-1A4F-9092F63C3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317787-C687-E5D0-1478-13E977267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078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F9F15D9-AA47-341B-5410-448E47095E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E0792F6-8F53-FEFD-9AD8-B9F988130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DDB6C1C-CB20-544B-0FB7-78EEAB1CA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9C84018-D4BC-DE7D-2240-7546F6C9B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576E11-9A3E-448D-54FC-8F1F8EF51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819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75BBFE-48EF-09C7-A75F-DF8D16B306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03AB848-9BE9-A5A1-D361-6C3C1B3DE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07CD18-429E-FFC1-E8C0-F912DB4DD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9963138-E2CA-AF28-DE6F-AFBEE163B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74BCBF9-3101-74E2-0DAF-D3FF617CD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252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96D001-6649-3269-D9AA-F1023BD26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D7D097-9A4A-0ABB-CA78-BBADBE9237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EFB8A7-B6EC-FF11-0B5D-7D359EE19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13FE213-8F1B-064D-9B2F-3C3D3B699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EE6FAD4-EF5C-1902-8877-4EBC90AED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72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DC3ECE-F308-F061-A1FC-8442D2599D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B477975-F377-8530-3F20-F0FF238DC9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AFD667A-D968-C3BB-3EE4-FFD058D715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5A2F0D4-E10E-01CB-096A-1770D2189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75FE149-291F-8ADB-6A62-6E890EA3A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D6BFA60-3B41-6751-52D8-A14291B8D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842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60D30A-C27F-0CDD-C32F-AA601B7F2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64412C7-2E81-32DE-0692-3EDDEB787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3E2F3B4-4DD0-8BA5-C33A-BD433C0F95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C3F85BF-2B23-4375-DFCB-905B4062A8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C4DF05C-40CC-22B6-6561-D1D6BD0DDB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9D70B4D-CF20-A98B-5012-B66158E48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A191EDC-4CA9-BEB3-98FD-9CD097917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991007E-A13C-56E1-C542-5F284FE49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612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021ED4-2456-79F0-CC5B-9FE8219C6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AEC109A-BF87-3228-0FAA-9D8462C96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38EAB38-FF18-F859-8A6E-4851936F3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09AEBA2-7645-94A4-1352-4AEC9C531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022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31708B4-CC89-2E86-1E02-FD5E054DD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E975B0A-7EEC-0204-4334-7098161D1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66E98D7-0E53-9871-5D76-DB8DB05FD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96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595C2A-B6E7-AB0F-8E7F-4D1A30B1F1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FD6E763-3BEF-FB9C-FAE1-FF3A28589D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400FD8F-2FB8-7E80-2208-3678843919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2FE2C1-E287-50F2-C283-14F4CBAF1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CAEDD2D-9305-F79F-FC3E-B4D5B4157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8CDE6D-50B9-A202-6642-48192A627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666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21D0A3-E320-9D33-C646-4479763B5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9427053-4D0A-9480-2ADE-5CC7709466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F5F7480-D6AC-EF6E-8213-359FFEF03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7D7307C-B5B5-05F4-22A6-358E81C56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AD9B778-14D0-13D4-8CDF-7C4874F3A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4C6B816-13F6-1012-5DE1-A5F8EC296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476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82C1A3A-CD2C-F542-19DA-82ADF2275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CF84DFD-C09E-CA76-A1C6-376379A58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AC94B7D-BE11-0BA3-52CA-AE06D6B750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2CC56-E691-488D-88DA-76A83D195200}" type="datetimeFigureOut">
              <a:rPr lang="en-US" smtClean="0"/>
              <a:t>8/30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D73D43-17B6-0EFA-7257-361B3BC2DF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BDC40D-6AD8-E1E0-8891-1D4A9DB02D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364FD-D93B-4737-B833-7A841F260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943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E8A7944A-9829-7D51-6A25-B715659F31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5607" y="1314110"/>
            <a:ext cx="8920786" cy="4229781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180329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orest plot of the age in patients and controls. 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3E8B2A73-57C9-48FD-E121-EAF85DEC151C}"/>
              </a:ext>
            </a:extLst>
          </p:cNvPr>
          <p:cNvSpPr txBox="1"/>
          <p:nvPr/>
        </p:nvSpPr>
        <p:spPr>
          <a:xfrm>
            <a:off x="7651398" y="4820481"/>
            <a:ext cx="73289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6C10A677-A5B1-D13F-E459-270CB41E1DE0}"/>
              </a:ext>
            </a:extLst>
          </p:cNvPr>
          <p:cNvSpPr txBox="1"/>
          <p:nvPr/>
        </p:nvSpPr>
        <p:spPr>
          <a:xfrm>
            <a:off x="8980465" y="4820481"/>
            <a:ext cx="76495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02552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0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chorioamnionitis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BC6677BF-6C1B-524A-40E6-6CD8A870F8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62977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AACC1FF9-F3D4-B319-4FDD-4BFF86A7A618}"/>
              </a:ext>
            </a:extLst>
          </p:cNvPr>
          <p:cNvSpPr txBox="1"/>
          <p:nvPr/>
        </p:nvSpPr>
        <p:spPr>
          <a:xfrm>
            <a:off x="9460313" y="4721091"/>
            <a:ext cx="53412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8C01F6D-5142-C820-3E2B-F5A26B709AB9}"/>
              </a:ext>
            </a:extLst>
          </p:cNvPr>
          <p:cNvSpPr txBox="1"/>
          <p:nvPr/>
        </p:nvSpPr>
        <p:spPr>
          <a:xfrm>
            <a:off x="10159685" y="4721091"/>
            <a:ext cx="55335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66384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1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difference in birth weight in patients and controls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D7908890-AC93-A69F-F8A7-3BF014E56E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31444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A439DCBF-4023-D7E4-D2EC-FE3926D4C4BB}"/>
              </a:ext>
            </a:extLst>
          </p:cNvPr>
          <p:cNvSpPr txBox="1"/>
          <p:nvPr/>
        </p:nvSpPr>
        <p:spPr>
          <a:xfrm>
            <a:off x="9365090" y="4422919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3F53784F-2400-851E-C770-31E179D1CDA5}"/>
              </a:ext>
            </a:extLst>
          </p:cNvPr>
          <p:cNvSpPr txBox="1"/>
          <p:nvPr/>
        </p:nvSpPr>
        <p:spPr>
          <a:xfrm>
            <a:off x="10143175" y="4422919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95472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223932"/>
            <a:ext cx="11549270" cy="646331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2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difference in pre-term delivery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0274F10B-AEFC-0DA6-13AE-4CCAC104C9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20934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696C755D-4201-0B42-E6A6-ECEAF42F48E2}"/>
              </a:ext>
            </a:extLst>
          </p:cNvPr>
          <p:cNvSpPr txBox="1"/>
          <p:nvPr/>
        </p:nvSpPr>
        <p:spPr>
          <a:xfrm>
            <a:off x="9410620" y="4701213"/>
            <a:ext cx="53412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33B075D8-1471-BE4C-5B0A-CC62720EFDAA}"/>
              </a:ext>
            </a:extLst>
          </p:cNvPr>
          <p:cNvSpPr txBox="1"/>
          <p:nvPr/>
        </p:nvSpPr>
        <p:spPr>
          <a:xfrm>
            <a:off x="10060297" y="4701213"/>
            <a:ext cx="55335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7216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3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cesarean delivery in patients and controls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62BE46A4-142D-4088-48DA-59E92D3468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1036549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17B02000-1EA7-9C3A-8A9F-7656F6C1BC2E}"/>
              </a:ext>
            </a:extLst>
          </p:cNvPr>
          <p:cNvSpPr txBox="1"/>
          <p:nvPr/>
        </p:nvSpPr>
        <p:spPr>
          <a:xfrm>
            <a:off x="9384970" y="5198167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37A02A03-9CB0-11DC-654B-0EA36F2196B9}"/>
              </a:ext>
            </a:extLst>
          </p:cNvPr>
          <p:cNvSpPr txBox="1"/>
          <p:nvPr/>
        </p:nvSpPr>
        <p:spPr>
          <a:xfrm>
            <a:off x="10103420" y="5198167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09214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223932"/>
            <a:ext cx="11549270" cy="646331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4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difference in gestational age at delivery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1FB8C740-0114-13C5-8876-ECD8866890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1005017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49825C0A-3600-5511-A67B-A904C4011C29}"/>
              </a:ext>
            </a:extLst>
          </p:cNvPr>
          <p:cNvSpPr txBox="1"/>
          <p:nvPr/>
        </p:nvSpPr>
        <p:spPr>
          <a:xfrm>
            <a:off x="9375031" y="4403039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054C2D1A-9FA6-E8CE-768D-C4B9BFC2428C}"/>
              </a:ext>
            </a:extLst>
          </p:cNvPr>
          <p:cNvSpPr txBox="1"/>
          <p:nvPr/>
        </p:nvSpPr>
        <p:spPr>
          <a:xfrm>
            <a:off x="10133237" y="4403039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5518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223932"/>
            <a:ext cx="11549270" cy="646331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5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small for gestational age in patients and controls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15840E18-2FF3-D706-8C08-721F5B32F8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73487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7E1B6EC7-894D-8399-B92E-7E4DB21417EB}"/>
              </a:ext>
            </a:extLst>
          </p:cNvPr>
          <p:cNvSpPr txBox="1"/>
          <p:nvPr/>
        </p:nvSpPr>
        <p:spPr>
          <a:xfrm>
            <a:off x="9430495" y="4552125"/>
            <a:ext cx="53412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DF9B0DD-4655-7FA2-58A8-A7C3C342E80D}"/>
              </a:ext>
            </a:extLst>
          </p:cNvPr>
          <p:cNvSpPr txBox="1"/>
          <p:nvPr/>
        </p:nvSpPr>
        <p:spPr>
          <a:xfrm>
            <a:off x="10100051" y="4552125"/>
            <a:ext cx="55335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793183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16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fetal death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70773646-C211-C827-79D5-892CFBD305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494" y="920934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EC2C0AEA-998C-861A-B2FB-E1210710C3E8}"/>
              </a:ext>
            </a:extLst>
          </p:cNvPr>
          <p:cNvSpPr txBox="1"/>
          <p:nvPr/>
        </p:nvSpPr>
        <p:spPr>
          <a:xfrm>
            <a:off x="9470253" y="4552127"/>
            <a:ext cx="53412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BF15096-5192-2C58-32AE-036B16639490}"/>
              </a:ext>
            </a:extLst>
          </p:cNvPr>
          <p:cNvSpPr txBox="1"/>
          <p:nvPr/>
        </p:nvSpPr>
        <p:spPr>
          <a:xfrm>
            <a:off x="10149747" y="4552127"/>
            <a:ext cx="55335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216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17212"/>
            <a:ext cx="11549270" cy="555280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2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age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F015331-10F2-CAC3-6289-724F960A50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75" y="672662"/>
            <a:ext cx="10704252" cy="6021141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F6A8781B-50FB-61C9-1BEF-128735B69BA4}"/>
              </a:ext>
            </a:extLst>
          </p:cNvPr>
          <p:cNvSpPr txBox="1"/>
          <p:nvPr/>
        </p:nvSpPr>
        <p:spPr>
          <a:xfrm>
            <a:off x="9633450" y="4492493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C27456BD-A863-8D7A-4AD6-3AA38C5ECFEC}"/>
              </a:ext>
            </a:extLst>
          </p:cNvPr>
          <p:cNvSpPr txBox="1"/>
          <p:nvPr/>
        </p:nvSpPr>
        <p:spPr>
          <a:xfrm>
            <a:off x="10361839" y="4492493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8353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239392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3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orest plot of the body mass index in patients and controls. 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51327B0D-03C8-F50E-8C0B-FDBA565A51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8116" y="1764087"/>
            <a:ext cx="9235768" cy="3329827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9A76339C-EBCD-3F09-4F11-6C274CD50A60}"/>
              </a:ext>
            </a:extLst>
          </p:cNvPr>
          <p:cNvSpPr txBox="1"/>
          <p:nvPr/>
        </p:nvSpPr>
        <p:spPr>
          <a:xfrm>
            <a:off x="7790544" y="4363281"/>
            <a:ext cx="73289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EA8250B5-C48C-A240-3F67-E005A55B2F98}"/>
              </a:ext>
            </a:extLst>
          </p:cNvPr>
          <p:cNvSpPr txBox="1"/>
          <p:nvPr/>
        </p:nvSpPr>
        <p:spPr>
          <a:xfrm>
            <a:off x="9139489" y="4363281"/>
            <a:ext cx="76495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3194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4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body mass index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22EF447-4F0D-562F-661B-ED112162FF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31445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BABD3A29-4EBF-E5FA-2C7A-FA91FE52F9D9}"/>
              </a:ext>
            </a:extLst>
          </p:cNvPr>
          <p:cNvSpPr txBox="1"/>
          <p:nvPr/>
        </p:nvSpPr>
        <p:spPr>
          <a:xfrm>
            <a:off x="9341045" y="4253950"/>
            <a:ext cx="53412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C1CA8C32-4AF5-53C9-F234-3EB3EC85C051}"/>
              </a:ext>
            </a:extLst>
          </p:cNvPr>
          <p:cNvSpPr txBox="1"/>
          <p:nvPr/>
        </p:nvSpPr>
        <p:spPr>
          <a:xfrm>
            <a:off x="10050358" y="4253950"/>
            <a:ext cx="55335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7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9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15247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5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orest plot of the risk for diabetes in patients and controls.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D626578C-F720-5155-5F4D-7904C4B073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900" y="1085850"/>
            <a:ext cx="7696200" cy="46863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B2F2FD05-6EF3-1862-B26E-0E4142948031}"/>
              </a:ext>
            </a:extLst>
          </p:cNvPr>
          <p:cNvSpPr txBox="1"/>
          <p:nvPr/>
        </p:nvSpPr>
        <p:spPr>
          <a:xfrm>
            <a:off x="7402921" y="5138531"/>
            <a:ext cx="73289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C16179CE-DADC-7F69-1D87-D3B7143C68A3}"/>
              </a:ext>
            </a:extLst>
          </p:cNvPr>
          <p:cNvSpPr txBox="1"/>
          <p:nvPr/>
        </p:nvSpPr>
        <p:spPr>
          <a:xfrm>
            <a:off x="8553086" y="5138531"/>
            <a:ext cx="76495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9554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6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diabetes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2B0A541-AF01-0054-9537-4F0FA3B471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73487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6132C117-68F1-B201-7176-C4AD44BFF348}"/>
              </a:ext>
            </a:extLst>
          </p:cNvPr>
          <p:cNvSpPr txBox="1"/>
          <p:nvPr/>
        </p:nvSpPr>
        <p:spPr>
          <a:xfrm>
            <a:off x="9375031" y="4870176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FCF5743C-7FDE-4CE7-78FF-F04B61CA7707}"/>
              </a:ext>
            </a:extLst>
          </p:cNvPr>
          <p:cNvSpPr txBox="1"/>
          <p:nvPr/>
        </p:nvSpPr>
        <p:spPr>
          <a:xfrm>
            <a:off x="10053724" y="4870176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52070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7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orest plot of the risk for hypertension in patients and controls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33C68226-0AF7-806C-410E-EA6A8A4BAB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834" y="1183766"/>
            <a:ext cx="7428332" cy="44904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0563DAE7-C23D-5822-60DE-18E56197E309}"/>
              </a:ext>
            </a:extLst>
          </p:cNvPr>
          <p:cNvSpPr txBox="1"/>
          <p:nvPr/>
        </p:nvSpPr>
        <p:spPr>
          <a:xfrm>
            <a:off x="7303530" y="5118651"/>
            <a:ext cx="73289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3AF8177-7110-961D-3E7C-CFFB72CDF63F}"/>
              </a:ext>
            </a:extLst>
          </p:cNvPr>
          <p:cNvSpPr txBox="1"/>
          <p:nvPr/>
        </p:nvSpPr>
        <p:spPr>
          <a:xfrm>
            <a:off x="8413939" y="5118651"/>
            <a:ext cx="76495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1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4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21545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8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hypertension in patients and controls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D5E4A65-0BFC-59B6-F8A7-3B91EF7AF0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878894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B69210E7-2EF4-0E74-489A-18C4A7A65632}"/>
              </a:ext>
            </a:extLst>
          </p:cNvPr>
          <p:cNvSpPr txBox="1"/>
          <p:nvPr/>
        </p:nvSpPr>
        <p:spPr>
          <a:xfrm>
            <a:off x="9305459" y="4870176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63BA1D5E-8861-8A15-E190-96AB97CA2710}"/>
              </a:ext>
            </a:extLst>
          </p:cNvPr>
          <p:cNvSpPr txBox="1"/>
          <p:nvPr/>
        </p:nvSpPr>
        <p:spPr>
          <a:xfrm>
            <a:off x="10073604" y="4870176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4336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7C4B39F-2203-615B-0FAB-B735592653D1}"/>
              </a:ext>
            </a:extLst>
          </p:cNvPr>
          <p:cNvSpPr txBox="1"/>
          <p:nvPr/>
        </p:nvSpPr>
        <p:spPr>
          <a:xfrm>
            <a:off x="318052" y="362431"/>
            <a:ext cx="11549270" cy="369332"/>
          </a:xfrm>
          <a:prstGeom prst="rect">
            <a:avLst/>
          </a:prstGeom>
          <a:noFill/>
        </p:spPr>
        <p:txBody>
          <a:bodyPr wrap="square" anchor="ctr" anchorCtr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800" b="1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ure S9.</a:t>
            </a:r>
            <a:r>
              <a:rPr lang="en-US" sz="1800" dirty="0"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Funnel plot (A) and sensitivity analysis (B) of the risk for miscarriage in patients and controls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A2091497-A7D4-D36B-E451-6AF28499B8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84" y="920935"/>
            <a:ext cx="10076033" cy="56677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CFC9A74F-5297-A552-3AB3-BCD855447CDD}"/>
              </a:ext>
            </a:extLst>
          </p:cNvPr>
          <p:cNvSpPr txBox="1"/>
          <p:nvPr/>
        </p:nvSpPr>
        <p:spPr>
          <a:xfrm>
            <a:off x="9394908" y="4353343"/>
            <a:ext cx="58541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Patient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3DF6E50-BDC2-60D9-F1E2-2DEEF2B92FC2}"/>
              </a:ext>
            </a:extLst>
          </p:cNvPr>
          <p:cNvSpPr txBox="1"/>
          <p:nvPr/>
        </p:nvSpPr>
        <p:spPr>
          <a:xfrm>
            <a:off x="10123298" y="4353343"/>
            <a:ext cx="60625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Arial" panose="020B0604020202020204" pitchFamily="34" charset="0"/>
                <a:ea typeface="Tahoma" panose="020B0604030504040204"/>
                <a:cs typeface="Arial" panose="020B0604020202020204" pitchFamily="34" charset="0"/>
              </a:rPr>
              <a:t>Controls</a:t>
            </a:r>
            <a:endParaRPr lang="en-US" sz="1000" b="1" dirty="0">
              <a:latin typeface="Arial" panose="020B0604020202020204" pitchFamily="34" charset="0"/>
              <a:ea typeface="Tahoma" panose="020B0604030504040204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42227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370</Words>
  <Application>Microsoft Office PowerPoint</Application>
  <PresentationFormat>Widescreen</PresentationFormat>
  <Paragraphs>48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Tahoma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sella cannarella</dc:creator>
  <cp:lastModifiedBy>Iris Qiao</cp:lastModifiedBy>
  <cp:revision>3</cp:revision>
  <dcterms:created xsi:type="dcterms:W3CDTF">2023-08-05T15:14:53Z</dcterms:created>
  <dcterms:modified xsi:type="dcterms:W3CDTF">2023-08-30T01:24:38Z</dcterms:modified>
</cp:coreProperties>
</file>